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56" r:id="rId2"/>
  </p:sldIdLst>
  <p:sldSz cx="8999538" cy="12599988"/>
  <p:notesSz cx="6858000" cy="9144000"/>
  <p:defaultTextStyle>
    <a:defPPr>
      <a:defRPr lang="ko-KR"/>
    </a:defPPr>
    <a:lvl1pPr marL="0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1pPr>
    <a:lvl2pPr marL="565694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2pPr>
    <a:lvl3pPr marL="1131387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3pPr>
    <a:lvl4pPr marL="1697081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4pPr>
    <a:lvl5pPr marL="2262774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5pPr>
    <a:lvl6pPr marL="2828468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6pPr>
    <a:lvl7pPr marL="3394161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7pPr>
    <a:lvl8pPr marL="3959855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8pPr>
    <a:lvl9pPr marL="4525548" algn="l" defTabSz="1131387" rtl="0" eaLnBrk="1" latinLnBrk="1" hangingPunct="1">
      <a:defRPr sz="222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CC00FF"/>
    <a:srgbClr val="FF00FF"/>
    <a:srgbClr val="FF6600"/>
    <a:srgbClr val="FF9900"/>
    <a:srgbClr val="FF9933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193" autoAdjust="0"/>
  </p:normalViewPr>
  <p:slideViewPr>
    <p:cSldViewPr snapToGrid="0">
      <p:cViewPr varScale="1">
        <p:scale>
          <a:sx n="58" d="100"/>
          <a:sy n="58" d="100"/>
        </p:scale>
        <p:origin x="30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1592948797224089"/>
          <c:y val="0.1559991954887778"/>
          <c:w val="0.55157914145273268"/>
          <c:h val="0.8179845504048628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GSEA_BP_motility!$A$29:$A$46</c:f>
              <c:strCache>
                <c:ptCount val="18"/>
                <c:pt idx="0">
                  <c:v>Biological adhesion</c:v>
                </c:pt>
                <c:pt idx="1">
                  <c:v>Cell-cell adhesion</c:v>
                </c:pt>
                <c:pt idx="2">
                  <c:v>Glycoprotein metabolic process</c:v>
                </c:pt>
                <c:pt idx="3">
                  <c:v>Carbohydrate derivative metabolic process</c:v>
                </c:pt>
                <c:pt idx="4">
                  <c:v>Adherens junction organization</c:v>
                </c:pt>
                <c:pt idx="5">
                  <c:v>Regulation of response to stress</c:v>
                </c:pt>
                <c:pt idx="6">
                  <c:v>Cell-cell junction organization</c:v>
                </c:pt>
                <c:pt idx="7">
                  <c:v>Phosphatidylcholine metabolic process</c:v>
                </c:pt>
                <c:pt idx="8">
                  <c:v>Cell projection organization</c:v>
                </c:pt>
                <c:pt idx="9">
                  <c:v>Glycoprotein biosynthetic process</c:v>
                </c:pt>
                <c:pt idx="10">
                  <c:v>Cell motility</c:v>
                </c:pt>
                <c:pt idx="11">
                  <c:v>Negative regulation of cell-cell adhesion</c:v>
                </c:pt>
                <c:pt idx="12">
                  <c:v>Cytoskeleton organization</c:v>
                </c:pt>
                <c:pt idx="13">
                  <c:v>Cell junction organization</c:v>
                </c:pt>
                <c:pt idx="14">
                  <c:v>Regulation of cell adhesion</c:v>
                </c:pt>
                <c:pt idx="15">
                  <c:v>Negative regulation of cell adhesion</c:v>
                </c:pt>
                <c:pt idx="16">
                  <c:v>Regulation of cellular response to stress</c:v>
                </c:pt>
                <c:pt idx="17">
                  <c:v>Proteoglycan metabolic process</c:v>
                </c:pt>
              </c:strCache>
            </c:strRef>
          </c:cat>
          <c:val>
            <c:numRef>
              <c:f>GSEA_BP_motility!$B$29:$B$46</c:f>
              <c:numCache>
                <c:formatCode>General</c:formatCode>
                <c:ptCount val="18"/>
                <c:pt idx="0">
                  <c:v>7.1598939055432425</c:v>
                </c:pt>
                <c:pt idx="1">
                  <c:v>6.4225082001627749</c:v>
                </c:pt>
                <c:pt idx="2">
                  <c:v>6.1549019599857431</c:v>
                </c:pt>
                <c:pt idx="3">
                  <c:v>5.7144426909922261</c:v>
                </c:pt>
                <c:pt idx="4">
                  <c:v>5.1897674820049158</c:v>
                </c:pt>
                <c:pt idx="5">
                  <c:v>5.0710923097560476</c:v>
                </c:pt>
                <c:pt idx="6">
                  <c:v>4.7212463990471711</c:v>
                </c:pt>
                <c:pt idx="7">
                  <c:v>4.6108339156354674</c:v>
                </c:pt>
                <c:pt idx="8">
                  <c:v>4.3372421683184257</c:v>
                </c:pt>
                <c:pt idx="9">
                  <c:v>4.2298847052128981</c:v>
                </c:pt>
                <c:pt idx="10">
                  <c:v>4.0814454694497266</c:v>
                </c:pt>
                <c:pt idx="11">
                  <c:v>3.9788107009300617</c:v>
                </c:pt>
                <c:pt idx="12">
                  <c:v>3.9625735020593762</c:v>
                </c:pt>
                <c:pt idx="13">
                  <c:v>3.9507819773298185</c:v>
                </c:pt>
                <c:pt idx="14">
                  <c:v>3.8297382846050425</c:v>
                </c:pt>
                <c:pt idx="15">
                  <c:v>3.7423214251308154</c:v>
                </c:pt>
                <c:pt idx="16">
                  <c:v>3.642065152999546</c:v>
                </c:pt>
                <c:pt idx="17">
                  <c:v>3.37161106994968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30-4692-B51D-9386CB8C9B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961160544"/>
        <c:axId val="1961173856"/>
      </c:barChart>
      <c:catAx>
        <c:axId val="1961160544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961173856"/>
        <c:crosses val="autoZero"/>
        <c:auto val="1"/>
        <c:lblAlgn val="ctr"/>
        <c:lblOffset val="100"/>
        <c:noMultiLvlLbl val="0"/>
      </c:catAx>
      <c:valAx>
        <c:axId val="1961173856"/>
        <c:scaling>
          <c:orientation val="minMax"/>
        </c:scaling>
        <c:delete val="0"/>
        <c:axPos val="t"/>
        <c:majorGridlines>
          <c:spPr>
            <a:ln w="12700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</a:t>
                </a:r>
                <a:r>
                  <a:rPr lang="en-US" baseline="-25000"/>
                  <a:t>10</a:t>
                </a:r>
                <a:r>
                  <a:rPr lang="en-US"/>
                  <a:t>(p-value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6188917645188412"/>
              <c:y val="3.547671014503549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961160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C70B5B-111F-4779-A15E-A447459ADD4A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CA0B5-EB5F-478B-9237-DF435E496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7517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1pPr>
    <a:lvl2pPr marL="565694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2pPr>
    <a:lvl3pPr marL="1131387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3pPr>
    <a:lvl4pPr marL="1697081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4pPr>
    <a:lvl5pPr marL="2262774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5pPr>
    <a:lvl6pPr marL="2828468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6pPr>
    <a:lvl7pPr marL="3394161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7pPr>
    <a:lvl8pPr marL="3959855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8pPr>
    <a:lvl9pPr marL="4525548" algn="l" defTabSz="1131387" rtl="0" eaLnBrk="1" latinLnBrk="1" hangingPunct="1">
      <a:defRPr sz="148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indent="-342900">
              <a:buAutoNum type="alphaUcPeriod"/>
            </a:pPr>
            <a:r>
              <a:rPr lang="en-US" altLang="ko-KR" dirty="0" smtClean="0"/>
              <a:t>Gene set</a:t>
            </a:r>
            <a:r>
              <a:rPr lang="en-US" altLang="ko-KR" baseline="0" dirty="0" smtClean="0"/>
              <a:t> enrichment analysis (q &lt; 0.05)</a:t>
            </a:r>
          </a:p>
          <a:p>
            <a:pPr marL="342900" indent="-342900">
              <a:buAutoNum type="alphaUcPeriod"/>
            </a:pPr>
            <a:r>
              <a:rPr lang="en-US" altLang="ko-KR" sz="1485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ological</a:t>
            </a:r>
            <a:r>
              <a:rPr lang="en-US" altLang="ko-KR" sz="1485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cess enrichment (min overlap = 3, p &lt; 0.01, min enrichment = 1.5)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8CA0B5-EB5F-478B-9237-DF435E496D1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10489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062083"/>
            <a:ext cx="7649607" cy="438666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6617911"/>
            <a:ext cx="6749654" cy="3042080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710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425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670833"/>
            <a:ext cx="1940525" cy="1067790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70833"/>
            <a:ext cx="5709082" cy="1067790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0788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3640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141251"/>
            <a:ext cx="7762102" cy="524124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8432079"/>
            <a:ext cx="7762102" cy="275624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8057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354163"/>
            <a:ext cx="3824804" cy="799457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354163"/>
            <a:ext cx="3824804" cy="799457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4700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70836"/>
            <a:ext cx="7762102" cy="243541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088748"/>
            <a:ext cx="3807226" cy="1513748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4602496"/>
            <a:ext cx="3807226" cy="676957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088748"/>
            <a:ext cx="3825976" cy="1513748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602496"/>
            <a:ext cx="3825976" cy="676957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5075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7074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109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39999"/>
            <a:ext cx="2902585" cy="2939997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814168"/>
            <a:ext cx="4556016" cy="895415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779996"/>
            <a:ext cx="2902585" cy="7002911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584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39999"/>
            <a:ext cx="2902585" cy="2939997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814168"/>
            <a:ext cx="4556016" cy="895415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779996"/>
            <a:ext cx="2902585" cy="7002911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7964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670836"/>
            <a:ext cx="7762102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354163"/>
            <a:ext cx="7762102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1678325"/>
            <a:ext cx="20248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A20D1A-BBAC-477A-BDB3-EFD426AD4774}" type="datetimeFigureOut">
              <a:rPr lang="ko-KR" altLang="en-US" smtClean="0"/>
              <a:t>2021-03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1678325"/>
            <a:ext cx="3037344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1678325"/>
            <a:ext cx="20248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06F1B-5F34-48A7-82C9-16152850C2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7381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476149" y="799371"/>
            <a:ext cx="8085445" cy="11062670"/>
            <a:chOff x="193522" y="549993"/>
            <a:chExt cx="8085445" cy="11062670"/>
          </a:xfrm>
        </p:grpSpPr>
        <p:sp>
          <p:nvSpPr>
            <p:cNvPr id="9" name="TextBox 8"/>
            <p:cNvSpPr txBox="1"/>
            <p:nvPr/>
          </p:nvSpPr>
          <p:spPr>
            <a:xfrm>
              <a:off x="199058" y="563563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8498" y="6278589"/>
              <a:ext cx="7560469" cy="5334074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93522" y="5892918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060730" y="8349137"/>
              <a:ext cx="23246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ycoprotein metabolic process</a:t>
              </a:r>
              <a:endParaRPr lang="ko-KR" altLang="en-US" sz="1200" dirty="0">
                <a:solidFill>
                  <a:srgbClr val="CC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197895" y="8979268"/>
              <a:ext cx="18950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junction organization</a:t>
              </a:r>
              <a:endParaRPr lang="ko-KR" altLang="en-US" sz="12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77555" y="6278589"/>
              <a:ext cx="28424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osphatidylcholine metabolic process</a:t>
              </a:r>
              <a:endParaRPr lang="ko-KR" altLang="en-US" sz="12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81365" y="6728704"/>
              <a:ext cx="20233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rgbClr val="FF66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gulation of cell adhesion</a:t>
              </a:r>
              <a:endParaRPr lang="ko-KR" altLang="en-US" sz="1200" dirty="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38567" y="8663827"/>
              <a:ext cx="29129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rgbClr val="CC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gulation of cellular response to stress</a:t>
              </a:r>
              <a:endParaRPr lang="ko-KR" altLang="en-US" sz="1200" dirty="0">
                <a:solidFill>
                  <a:srgbClr val="CC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2495" y="9535707"/>
              <a:ext cx="18453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projection assembly</a:t>
              </a:r>
              <a:endParaRPr lang="ko-KR" altLang="en-US" sz="1200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61898" y="7765870"/>
              <a:ext cx="1580882" cy="276999"/>
            </a:xfrm>
            <a:prstGeom prst="rect">
              <a:avLst/>
            </a:prstGeom>
            <a:solidFill>
              <a:schemeClr val="bg1"/>
            </a:solidFill>
            <a:effectLst>
              <a:softEdge rad="63500"/>
            </a:effectLst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solidFill>
                    <a:schemeClr val="accent5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-matrix adhesion</a:t>
              </a:r>
              <a:endParaRPr lang="ko-KR" altLang="en-US" sz="1200" dirty="0">
                <a:solidFill>
                  <a:schemeClr val="accent5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" name="그룹 26"/>
            <p:cNvGrpSpPr/>
            <p:nvPr/>
          </p:nvGrpSpPr>
          <p:grpSpPr>
            <a:xfrm>
              <a:off x="6353175" y="10604075"/>
              <a:ext cx="619396" cy="877074"/>
              <a:chOff x="6391275" y="11055375"/>
              <a:chExt cx="619396" cy="877074"/>
            </a:xfrm>
          </p:grpSpPr>
          <p:sp>
            <p:nvSpPr>
              <p:cNvPr id="20" name="타원 19"/>
              <p:cNvSpPr/>
              <p:nvPr/>
            </p:nvSpPr>
            <p:spPr>
              <a:xfrm>
                <a:off x="6467475" y="11734800"/>
                <a:ext cx="108000" cy="108000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696075" y="1165545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타원 21"/>
              <p:cNvSpPr/>
              <p:nvPr/>
            </p:nvSpPr>
            <p:spPr>
              <a:xfrm>
                <a:off x="6429375" y="11420475"/>
                <a:ext cx="180000" cy="180000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696075" y="11369700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타원 23"/>
              <p:cNvSpPr/>
              <p:nvPr/>
            </p:nvSpPr>
            <p:spPr>
              <a:xfrm>
                <a:off x="6391275" y="11058525"/>
                <a:ext cx="252000" cy="252000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6667500" y="11055375"/>
                <a:ext cx="34317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6143625" y="10232600"/>
              <a:ext cx="1047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enes in BP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8" name="차트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54875142"/>
                </p:ext>
              </p:extLst>
            </p:nvPr>
          </p:nvGraphicFramePr>
          <p:xfrm>
            <a:off x="718498" y="549993"/>
            <a:ext cx="7560469" cy="53697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401314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6</TotalTime>
  <Words>67</Words>
  <Application>Microsoft Office PowerPoint</Application>
  <PresentationFormat>사용자 지정</PresentationFormat>
  <Paragraphs>1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1</cp:revision>
  <dcterms:created xsi:type="dcterms:W3CDTF">2021-03-09T01:30:36Z</dcterms:created>
  <dcterms:modified xsi:type="dcterms:W3CDTF">2021-03-30T08:37:31Z</dcterms:modified>
</cp:coreProperties>
</file>